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1A09B-B389-401D-B620-9CDE7BBB3A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0DC5EE-5790-429F-93CF-478D883C0E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214A50-E0D7-49E4-8159-83F2419A71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42B43B-0812-483D-82D5-6F49A9F0CF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67BF6-7416-4883-8D82-2155D837C0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9AF49-8942-449D-8BCE-995C53AE29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FC058-095C-4F1A-AE3C-C78A1F6D25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4A592-3C40-4F79-AD7C-EAB3845298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80D96-E956-43BF-A95B-275DA70776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EB214-7036-4C1A-876D-71AF6918FD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0CE24E-F2C5-44F4-8B6D-6474AB567B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64F59-9500-435B-A4F1-8209C2329F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6153DF-80D5-4EF4-A8DE-9870889B02CF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1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2"/>
          <p:cNvSpPr/>
          <p:nvPr/>
        </p:nvSpPr>
        <p:spPr>
          <a:xfrm>
            <a:off x="214200" y="135000"/>
            <a:ext cx="5052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VJ combination usage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1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44" name="文本框 2"/>
          <p:cNvSpPr/>
          <p:nvPr/>
        </p:nvSpPr>
        <p:spPr>
          <a:xfrm>
            <a:off x="197640" y="135000"/>
            <a:ext cx="3984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VJ combination usage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1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46" name="文本框 2"/>
          <p:cNvSpPr/>
          <p:nvPr/>
        </p:nvSpPr>
        <p:spPr>
          <a:xfrm>
            <a:off x="213840" y="135000"/>
            <a:ext cx="5151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VJ combination usage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1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3"/>
          <p:cNvSpPr/>
          <p:nvPr/>
        </p:nvSpPr>
        <p:spPr>
          <a:xfrm>
            <a:off x="210960" y="135000"/>
            <a:ext cx="4013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VJ combination usage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图片 3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50" name="文本框 2"/>
          <p:cNvSpPr/>
          <p:nvPr/>
        </p:nvSpPr>
        <p:spPr>
          <a:xfrm>
            <a:off x="212760" y="135000"/>
            <a:ext cx="5095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VJ combination usage(Pleural Effusion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图片 3" descr=""/>
          <p:cNvPicPr/>
          <p:nvPr/>
        </p:nvPicPr>
        <p:blipFill>
          <a:blip r:embed="rId1"/>
          <a:stretch/>
        </p:blipFill>
        <p:spPr>
          <a:xfrm>
            <a:off x="0" y="0"/>
            <a:ext cx="12192120" cy="6858000"/>
          </a:xfrm>
          <a:prstGeom prst="rect">
            <a:avLst/>
          </a:prstGeom>
          <a:ln w="0">
            <a:noFill/>
          </a:ln>
        </p:spPr>
      </p:pic>
      <p:sp>
        <p:nvSpPr>
          <p:cNvPr id="52" name="文本框 2"/>
          <p:cNvSpPr/>
          <p:nvPr/>
        </p:nvSpPr>
        <p:spPr>
          <a:xfrm>
            <a:off x="209880" y="135000"/>
            <a:ext cx="3957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VJ combination usage(Blood)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28T01:06:39Z</dcterms:created>
  <dc:creator>Li Hao</dc:creator>
  <dc:description/>
  <dc:language>en-US</dc:language>
  <cp:lastModifiedBy>Li Hao</cp:lastModifiedBy>
  <dcterms:modified xsi:type="dcterms:W3CDTF">2023-12-20T01:21:57Z</dcterms:modified>
  <cp:revision>68</cp:revision>
  <dc:subject/>
  <dc:title>PowerPoint 演示文稿</dc:title>
</cp:coreProperties>
</file>